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nl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6" autoAdjust="0"/>
    <p:restoredTop sz="94660"/>
  </p:normalViewPr>
  <p:slideViewPr>
    <p:cSldViewPr snapToGrid="0">
      <p:cViewPr>
        <p:scale>
          <a:sx n="90" d="100"/>
          <a:sy n="90" d="100"/>
        </p:scale>
        <p:origin x="-108" y="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C604556-12DB-125D-84C6-B8327DB18F4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B4DCABE8-13BA-F0B4-A55A-1CAC20397D6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ken om de ondertitelstijl van het model te bewerken</a:t>
            </a:r>
            <a:endParaRPr lang="en-US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FC3C593A-D59B-1D1A-0951-CBB3B03A65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1A1DE-D2D6-4A66-9B4D-FAE2F64F15EA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706B41A1-66CD-F242-43C0-7CE77B0680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62C3E7CC-18C5-1A7D-2876-3AD47BFA80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3664E-DF6D-4DC4-A856-B9A8435AAB9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19830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E89C98D-0C8E-B61A-A36D-C68B57EFC7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3F269604-FFF0-F9FE-C907-2A70066017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003ACE6A-9E96-5181-3142-CBA9D5FF58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1A1DE-D2D6-4A66-9B4D-FAE2F64F15EA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CD832552-3C8A-2F0A-3837-D0662821C6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33CAA13F-05D1-AFDD-CF73-14F7910922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3664E-DF6D-4DC4-A856-B9A8435AAB9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62400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>
            <a:extLst>
              <a:ext uri="{FF2B5EF4-FFF2-40B4-BE49-F238E27FC236}">
                <a16:creationId xmlns:a16="http://schemas.microsoft.com/office/drawing/2014/main" id="{79CA2ED3-860E-C12B-B3C4-6DA2E0968CA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D113670B-D9EA-7746-AED9-7F6C8539C5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91D9EA4B-36B8-DE8B-0A49-2ED1A2FE9F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1A1DE-D2D6-4A66-9B4D-FAE2F64F15EA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61FF1883-5A10-D0A7-A576-DDFF4729FC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802A1BE2-16E1-36E8-3AB3-2286BF46A7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3664E-DF6D-4DC4-A856-B9A8435AAB9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40356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D8DF1AF-A207-FECE-39E7-DAA89BAF74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106C3B8B-1CB3-2594-FFC6-58F6BDB9C8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865CFA27-82D0-6C82-822F-14FBA58CDB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1A1DE-D2D6-4A66-9B4D-FAE2F64F15EA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849C9993-E1CB-17B5-8E28-D9058888C1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BA5CF788-BD40-AA0C-19A8-72E9BC15EC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3664E-DF6D-4DC4-A856-B9A8435AAB9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01856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948BBFB-5076-5CE3-D378-2E8F5969CA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3C0EEF23-4431-25BE-4E69-06A2D746D1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92B0E771-5C60-CCB5-AC97-18565C782C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1A1DE-D2D6-4A66-9B4D-FAE2F64F15EA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D7F0822D-EE62-614A-92D7-FF5F86D02E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79F00674-1CEF-14E4-4B83-76612F1643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3664E-DF6D-4DC4-A856-B9A8435AAB9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51190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D76B651-BC0D-0D07-0398-346E0B3773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CF87F387-9CA1-AF1D-D008-AEE7052072F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021DC804-04DF-E28E-640C-833ED7CC9E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79491629-A573-50B2-BC5C-01992F3396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1A1DE-D2D6-4A66-9B4D-FAE2F64F15EA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52485B68-A729-32DC-8A2F-80098C4B24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25DDD153-E077-C83E-DB9F-979E8D131F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3664E-DF6D-4DC4-A856-B9A8435AAB9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9784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E369C1C-C6C9-A8C5-69A5-578883267F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26F6B560-9BA0-9D81-5FC1-43E72ABFAE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DD43C33B-E9F1-F35A-D1AE-BCE84B865F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5" name="Tijdelijke aanduiding voor tekst 4">
            <a:extLst>
              <a:ext uri="{FF2B5EF4-FFF2-40B4-BE49-F238E27FC236}">
                <a16:creationId xmlns:a16="http://schemas.microsoft.com/office/drawing/2014/main" id="{8CDCFE05-A354-7006-7413-32869B63CB5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Tijdelijke aanduiding voor inhoud 5">
            <a:extLst>
              <a:ext uri="{FF2B5EF4-FFF2-40B4-BE49-F238E27FC236}">
                <a16:creationId xmlns:a16="http://schemas.microsoft.com/office/drawing/2014/main" id="{C0C70227-746E-F651-8982-860EC0ED243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7" name="Tijdelijke aanduiding voor datum 6">
            <a:extLst>
              <a:ext uri="{FF2B5EF4-FFF2-40B4-BE49-F238E27FC236}">
                <a16:creationId xmlns:a16="http://schemas.microsoft.com/office/drawing/2014/main" id="{A8438DBB-4F54-F25F-6673-85AA5124AC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1A1DE-D2D6-4A66-9B4D-FAE2F64F15EA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8" name="Tijdelijke aanduiding voor voettekst 7">
            <a:extLst>
              <a:ext uri="{FF2B5EF4-FFF2-40B4-BE49-F238E27FC236}">
                <a16:creationId xmlns:a16="http://schemas.microsoft.com/office/drawing/2014/main" id="{FEA16687-06C9-32B1-5A39-B27E00051D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Tijdelijke aanduiding voor dianummer 8">
            <a:extLst>
              <a:ext uri="{FF2B5EF4-FFF2-40B4-BE49-F238E27FC236}">
                <a16:creationId xmlns:a16="http://schemas.microsoft.com/office/drawing/2014/main" id="{8FEC9A13-3D91-BEB0-DCCF-570037E7A8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3664E-DF6D-4DC4-A856-B9A8435AAB9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01078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315E437-5BDF-193E-2885-5DA16FBBF5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Tijdelijke aanduiding voor datum 2">
            <a:extLst>
              <a:ext uri="{FF2B5EF4-FFF2-40B4-BE49-F238E27FC236}">
                <a16:creationId xmlns:a16="http://schemas.microsoft.com/office/drawing/2014/main" id="{373D9119-B493-43EC-CBCF-6A6E2E2BFF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1A1DE-D2D6-4A66-9B4D-FAE2F64F15EA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4" name="Tijdelijke aanduiding voor voettekst 3">
            <a:extLst>
              <a:ext uri="{FF2B5EF4-FFF2-40B4-BE49-F238E27FC236}">
                <a16:creationId xmlns:a16="http://schemas.microsoft.com/office/drawing/2014/main" id="{4C95F068-D03B-6043-30A9-EBD9265E4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Tijdelijke aanduiding voor dianummer 4">
            <a:extLst>
              <a:ext uri="{FF2B5EF4-FFF2-40B4-BE49-F238E27FC236}">
                <a16:creationId xmlns:a16="http://schemas.microsoft.com/office/drawing/2014/main" id="{6397FD12-87E7-06D1-6C57-51E7D1EB19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3664E-DF6D-4DC4-A856-B9A8435AAB9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8032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>
            <a:extLst>
              <a:ext uri="{FF2B5EF4-FFF2-40B4-BE49-F238E27FC236}">
                <a16:creationId xmlns:a16="http://schemas.microsoft.com/office/drawing/2014/main" id="{58A9BAD2-1BE5-E73B-6098-6522EE98E0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1A1DE-D2D6-4A66-9B4D-FAE2F64F15EA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3" name="Tijdelijke aanduiding voor voettekst 2">
            <a:extLst>
              <a:ext uri="{FF2B5EF4-FFF2-40B4-BE49-F238E27FC236}">
                <a16:creationId xmlns:a16="http://schemas.microsoft.com/office/drawing/2014/main" id="{A35556CE-22AA-8147-1D98-6381E0AA51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Tijdelijke aanduiding voor dianummer 3">
            <a:extLst>
              <a:ext uri="{FF2B5EF4-FFF2-40B4-BE49-F238E27FC236}">
                <a16:creationId xmlns:a16="http://schemas.microsoft.com/office/drawing/2014/main" id="{F65C7ED0-800E-83EA-49BF-2C25115CAA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3664E-DF6D-4DC4-A856-B9A8435AAB9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71985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1CC90F4-B8C6-D8B9-B675-45E74FCFAB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AB0F0166-0481-A820-2E57-8A7A8ACE184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A23099A1-32B9-BA4E-B827-B3C88F8D02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0DB91C78-5C53-02AD-5AC9-908EA9121E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1A1DE-D2D6-4A66-9B4D-FAE2F64F15EA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8BA0CE4F-4E12-44CD-3513-715CA370CD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A43D10AB-4D49-761D-0D5D-81BAEF10FC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3664E-DF6D-4DC4-A856-B9A8435AAB9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22431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1B429CC-BA36-9DED-B34B-78FFC720C4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Tijdelijke aanduiding voor afbeelding 2">
            <a:extLst>
              <a:ext uri="{FF2B5EF4-FFF2-40B4-BE49-F238E27FC236}">
                <a16:creationId xmlns:a16="http://schemas.microsoft.com/office/drawing/2014/main" id="{36C653DD-2A44-5F18-EAAF-A8DEE445A1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6E2110A1-EEFB-F30B-E7F7-E47BFCA875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6D356574-4945-766A-E0F8-A56716250D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1A1DE-D2D6-4A66-9B4D-FAE2F64F15EA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D173937E-2506-0C8E-B9DB-2B5325C59B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E84F6FCC-0B81-64C2-DCE9-FF94A482EB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3664E-DF6D-4DC4-A856-B9A8435AAB9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91871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>
            <a:extLst>
              <a:ext uri="{FF2B5EF4-FFF2-40B4-BE49-F238E27FC236}">
                <a16:creationId xmlns:a16="http://schemas.microsoft.com/office/drawing/2014/main" id="{EFDF484A-055D-2DB6-8EC8-88B5FD928F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F401CB26-85A7-71B0-F86D-4BAF9D7068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B43B0534-807D-1DBE-AC3E-19B8E7F4697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D1A1DE-D2D6-4A66-9B4D-FAE2F64F15EA}" type="datetimeFigureOut">
              <a:rPr lang="en-US" smtClean="0"/>
              <a:t>9/19/2023</a:t>
            </a:fld>
            <a:endParaRPr lang="en-US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FBF6176D-F3EA-2BF2-D230-86824A5332F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BEAB1C1A-C2A2-5C6F-D8BF-855C11C796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D3664E-DF6D-4DC4-A856-B9A8435AAB9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8456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B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" name="Tabel 18">
            <a:extLst>
              <a:ext uri="{FF2B5EF4-FFF2-40B4-BE49-F238E27FC236}">
                <a16:creationId xmlns:a16="http://schemas.microsoft.com/office/drawing/2014/main" id="{9936F50C-D31B-3F9A-AFCE-044A0C0FDF5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6614229"/>
              </p:ext>
            </p:extLst>
          </p:nvPr>
        </p:nvGraphicFramePr>
        <p:xfrm>
          <a:off x="1944915" y="4916714"/>
          <a:ext cx="8955313" cy="1854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46200">
                  <a:extLst>
                    <a:ext uri="{9D8B030D-6E8A-4147-A177-3AD203B41FA5}">
                      <a16:colId xmlns:a16="http://schemas.microsoft.com/office/drawing/2014/main" val="3565349616"/>
                    </a:ext>
                  </a:extLst>
                </a:gridCol>
                <a:gridCol w="845457">
                  <a:extLst>
                    <a:ext uri="{9D8B030D-6E8A-4147-A177-3AD203B41FA5}">
                      <a16:colId xmlns:a16="http://schemas.microsoft.com/office/drawing/2014/main" val="2344523312"/>
                    </a:ext>
                  </a:extLst>
                </a:gridCol>
                <a:gridCol w="845457">
                  <a:extLst>
                    <a:ext uri="{9D8B030D-6E8A-4147-A177-3AD203B41FA5}">
                      <a16:colId xmlns:a16="http://schemas.microsoft.com/office/drawing/2014/main" val="1429402988"/>
                    </a:ext>
                  </a:extLst>
                </a:gridCol>
                <a:gridCol w="845457">
                  <a:extLst>
                    <a:ext uri="{9D8B030D-6E8A-4147-A177-3AD203B41FA5}">
                      <a16:colId xmlns:a16="http://schemas.microsoft.com/office/drawing/2014/main" val="626740431"/>
                    </a:ext>
                  </a:extLst>
                </a:gridCol>
                <a:gridCol w="845457">
                  <a:extLst>
                    <a:ext uri="{9D8B030D-6E8A-4147-A177-3AD203B41FA5}">
                      <a16:colId xmlns:a16="http://schemas.microsoft.com/office/drawing/2014/main" val="908626044"/>
                    </a:ext>
                  </a:extLst>
                </a:gridCol>
                <a:gridCol w="845457">
                  <a:extLst>
                    <a:ext uri="{9D8B030D-6E8A-4147-A177-3AD203B41FA5}">
                      <a16:colId xmlns:a16="http://schemas.microsoft.com/office/drawing/2014/main" val="3183466356"/>
                    </a:ext>
                  </a:extLst>
                </a:gridCol>
                <a:gridCol w="845457">
                  <a:extLst>
                    <a:ext uri="{9D8B030D-6E8A-4147-A177-3AD203B41FA5}">
                      <a16:colId xmlns:a16="http://schemas.microsoft.com/office/drawing/2014/main" val="901680453"/>
                    </a:ext>
                  </a:extLst>
                </a:gridCol>
                <a:gridCol w="845457">
                  <a:extLst>
                    <a:ext uri="{9D8B030D-6E8A-4147-A177-3AD203B41FA5}">
                      <a16:colId xmlns:a16="http://schemas.microsoft.com/office/drawing/2014/main" val="2544244906"/>
                    </a:ext>
                  </a:extLst>
                </a:gridCol>
                <a:gridCol w="845457">
                  <a:extLst>
                    <a:ext uri="{9D8B030D-6E8A-4147-A177-3AD203B41FA5}">
                      <a16:colId xmlns:a16="http://schemas.microsoft.com/office/drawing/2014/main" val="1148641973"/>
                    </a:ext>
                  </a:extLst>
                </a:gridCol>
                <a:gridCol w="845457">
                  <a:extLst>
                    <a:ext uri="{9D8B030D-6E8A-4147-A177-3AD203B41FA5}">
                      <a16:colId xmlns:a16="http://schemas.microsoft.com/office/drawing/2014/main" val="3717499185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100" b="1" dirty="0"/>
                        <a:t>Week (number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0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1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4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7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15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22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31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44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61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0540587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100" b="1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Venesection </a:t>
                      </a:r>
                      <a:endParaRPr lang="en-US" sz="11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Yes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Yes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Yes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Yes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No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No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Yes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Yes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Yes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2367481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100" b="1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ematocrit (%)</a:t>
                      </a:r>
                      <a:endParaRPr lang="en-US" sz="11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0.9</a:t>
                      </a:r>
                      <a:endParaRPr lang="nl-BE" sz="11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66.6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61.5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57.0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33.0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31.3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36.9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40.0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43.3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8732233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Hemoglobin (g/L)</a:t>
                      </a:r>
                      <a:endParaRPr lang="nl-B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42</a:t>
                      </a:r>
                      <a:endParaRPr lang="en-US" sz="1100" dirty="0"/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222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206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189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107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96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110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118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129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363777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hrombocyte count (x10^9/L)</a:t>
                      </a:r>
                      <a:endParaRPr lang="nl-B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72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87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130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136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241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229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247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202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151</a:t>
                      </a:r>
                    </a:p>
                  </a:txBody>
                  <a:tcPr marT="36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24846287"/>
                  </a:ext>
                </a:extLst>
              </a:tr>
            </a:tbl>
          </a:graphicData>
        </a:graphic>
      </p:graphicFrame>
      <p:sp>
        <p:nvSpPr>
          <p:cNvPr id="19" name="Tekstvak 18">
            <a:extLst>
              <a:ext uri="{FF2B5EF4-FFF2-40B4-BE49-F238E27FC236}">
                <a16:creationId xmlns:a16="http://schemas.microsoft.com/office/drawing/2014/main" id="{5CA272E1-71AF-FA74-260A-B50796DFC246}"/>
              </a:ext>
            </a:extLst>
          </p:cNvPr>
          <p:cNvSpPr txBox="1"/>
          <p:nvPr/>
        </p:nvSpPr>
        <p:spPr>
          <a:xfrm>
            <a:off x="1513737" y="608522"/>
            <a:ext cx="4281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23" name="Tekstvak 22">
            <a:extLst>
              <a:ext uri="{FF2B5EF4-FFF2-40B4-BE49-F238E27FC236}">
                <a16:creationId xmlns:a16="http://schemas.microsoft.com/office/drawing/2014/main" id="{91759B8D-0E5C-D5AE-EEF6-107B74A6B8BD}"/>
              </a:ext>
            </a:extLst>
          </p:cNvPr>
          <p:cNvSpPr txBox="1"/>
          <p:nvPr/>
        </p:nvSpPr>
        <p:spPr>
          <a:xfrm>
            <a:off x="1513737" y="4476625"/>
            <a:ext cx="4281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pic>
        <p:nvPicPr>
          <p:cNvPr id="2" name="Afbeelding 1">
            <a:extLst>
              <a:ext uri="{FF2B5EF4-FFF2-40B4-BE49-F238E27FC236}">
                <a16:creationId xmlns:a16="http://schemas.microsoft.com/office/drawing/2014/main" id="{3B0B856C-208D-3FD3-7729-FAF59A3E556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1910" y="666556"/>
            <a:ext cx="8121806" cy="4121367"/>
          </a:xfrm>
          <a:prstGeom prst="rect">
            <a:avLst/>
          </a:prstGeom>
        </p:spPr>
      </p:pic>
      <p:sp>
        <p:nvSpPr>
          <p:cNvPr id="3" name="Tekstvak 2">
            <a:extLst>
              <a:ext uri="{FF2B5EF4-FFF2-40B4-BE49-F238E27FC236}">
                <a16:creationId xmlns:a16="http://schemas.microsoft.com/office/drawing/2014/main" id="{BFB78EE1-3407-B94B-6420-5B4854B5F11B}"/>
              </a:ext>
            </a:extLst>
          </p:cNvPr>
          <p:cNvSpPr txBox="1"/>
          <p:nvPr/>
        </p:nvSpPr>
        <p:spPr>
          <a:xfrm>
            <a:off x="340241" y="85060"/>
            <a:ext cx="9542721" cy="375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l figure 1: Overview of hematocrit and thrombocyte count during follow-up</a:t>
            </a:r>
            <a:endParaRPr lang="nl-B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60179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793002589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</TotalTime>
  <Words>79</Words>
  <Application>Microsoft Office PowerPoint</Application>
  <PresentationFormat>Breedbeeld</PresentationFormat>
  <Paragraphs>53</Paragraphs>
  <Slides>2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Diatitel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Kantoorthema</vt:lpstr>
      <vt:lpstr>PowerPoint-presentatie</vt:lpstr>
      <vt:lpstr>PowerPoint-presentati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Gaël Vermeersch</dc:creator>
  <cp:lastModifiedBy>Gaël Vermeersch</cp:lastModifiedBy>
  <cp:revision>7</cp:revision>
  <dcterms:created xsi:type="dcterms:W3CDTF">2022-09-10T17:51:39Z</dcterms:created>
  <dcterms:modified xsi:type="dcterms:W3CDTF">2023-09-19T18:35:39Z</dcterms:modified>
</cp:coreProperties>
</file>